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2" r:id="rId2"/>
  </p:sldIdLst>
  <p:sldSz cx="12192000" cy="6858000"/>
  <p:notesSz cx="6797675" cy="992822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dy&amp;Fede" initials="A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FC000"/>
    <a:srgbClr val="BC3C29"/>
    <a:srgbClr val="4472C4"/>
    <a:srgbClr val="D78B7F"/>
    <a:srgbClr val="0070C1"/>
    <a:srgbClr val="909090"/>
    <a:srgbClr val="EEBB00"/>
    <a:srgbClr val="FF8000"/>
    <a:srgbClr val="0000FF"/>
    <a:srgbClr val="09996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–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786" autoAdjust="0"/>
    <p:restoredTop sz="94626"/>
  </p:normalViewPr>
  <p:slideViewPr>
    <p:cSldViewPr snapToGrid="0">
      <p:cViewPr varScale="1">
        <p:scale>
          <a:sx n="115" d="100"/>
          <a:sy n="115" d="100"/>
        </p:scale>
        <p:origin x="269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FFB83E-C48E-447E-9B3B-133D6A49D7EE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F49B13-6FF4-4488-95DA-3919E18726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59953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F49B13-6FF4-4488-95DA-3919E187264A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080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A63C0C-5577-4C4F-61B3-CAFB123513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A603D7D-CEDD-0E8C-733F-1419457099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8235D4-5E28-43CC-4258-10D5F57B8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88FB44-08E5-DC01-F286-00A4B70CA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9D877C2-5464-507D-9398-03A3954C4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6497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55BF24-0E63-E15D-0FB7-6DED958D6E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6F4C177-79C7-F108-008D-55C2DB7060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34BE381-0992-F1D1-47A1-D82412118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9067EC9-B9E8-9182-06AE-3D28BFF98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6D62368-E692-E3D8-85A8-A9760E775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667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B6A7F61-ACE5-5156-1B30-49C52B4F7D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0801A64-95FE-B96E-B84E-D892265FE7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693709-87BF-F58D-A0C8-091B34C12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0CD796-6F33-DF2E-3351-C9A261969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FCB49C7-3337-9EE1-CC4B-A57EE1D14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5806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34808E-2EBC-C139-9D9D-4BD441DA0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5B8B1B5-AF78-546E-1B4F-3B72E71BC5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A1BC50-4AFE-3E13-8410-C351AA72B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BE9C010-CE3B-EEDC-B29C-F358AAD89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00AB1A3-863D-D8AE-A5C2-4506665F7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3770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CECB986-6728-CA75-D17B-453452C00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504A5FD-A86A-D366-A583-981DE08834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AB1E49-EAB1-E1AB-FA38-F86BAFE38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3B0A145-6BA2-FFE0-05CC-06367F3F4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7B737D9-BE9B-7F61-C270-66ADD4B6E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5596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1DA176-9AEF-86A0-F853-93C569731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7EC949C-DECD-3F5C-9081-E837876ED4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1ADA58F-20A5-8915-5085-F6E80775AC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8725F3F-94E5-3B09-4810-6F8AB0076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850594C-1CE5-043C-1F64-D8D77BF75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96FF6CC-5708-74BF-ED94-E3E857F3E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8148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792884-E46C-7B85-42C6-0100C1ABF0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BD0A09C-C24B-1866-FC96-B9F4C7E95A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F1F5CB0-6543-A984-7EF7-7815646F1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46EB3B6-1505-4468-6143-C658F31EBF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4C82EC3-B6CF-B4F8-A541-245CBF0EBA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5D12E8C-B186-5A7E-BDB9-6EDEAE98E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EB10F3A-2B17-3E0C-5B31-371A9444A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29D86D7-A67F-BC78-13A0-B8225D41D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9179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862856-CEAD-F763-03ED-ADAFCB54A9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B020A37-17B0-BDCD-E5E9-EED476A7D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108FC7F-14D6-FBEC-16B3-392247F5A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60DF6CA-D338-828B-87C9-16AE0A244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0379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A4D705D-6731-3F07-784A-21C538175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B681606-DC1A-7757-FB04-1591E3AC4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6483D9F-9708-6D4A-35CA-7F78CBC4C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250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1FB8B3C-31B6-5DA6-3C01-C47FF05C7C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F3FECB9-35C2-12D2-C0CD-1E2FEDB41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BD989E8-83D8-8F0F-A3BF-2BEC740C55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A96B903-B458-252B-17FA-3B4F6A23C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0EDD6C9-0DE3-A03D-4B8D-AC2A274040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B092D31-AA36-9F61-447A-01421E7B1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1690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3A27E8-DF0C-AC6A-5538-C06A86CD3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EAAA7EB-851F-32CC-D3EB-8C30D2AA72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FEA5DBA-8946-549E-49FF-A963F8924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CD64142-E4FE-4056-6459-99012726D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D0E2D54-7485-9ED6-5B32-EDC22F6FC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AA6305A-BC26-554B-6728-9DFD3DE39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823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E6D9B43-DA48-B1BD-F6A8-DEF111A76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D41DCF3-5DF7-90C3-3022-EE4630C32C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4337486-CF24-BF87-82A2-D50C982582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2E592BA-4B9A-BC56-5D65-520F78FDF8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4412DB8-AEFC-A7A2-C09A-EE8DD88FBF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8314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A58AC9C1-5F6F-810F-B97C-5E84169A319D}"/>
              </a:ext>
            </a:extLst>
          </p:cNvPr>
          <p:cNvSpPr txBox="1"/>
          <p:nvPr/>
        </p:nvSpPr>
        <p:spPr>
          <a:xfrm>
            <a:off x="105697" y="123036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a</a:t>
            </a:r>
          </a:p>
        </p:txBody>
      </p:sp>
      <p:grpSp>
        <p:nvGrpSpPr>
          <p:cNvPr id="4" name="Gruppo 3">
            <a:extLst>
              <a:ext uri="{FF2B5EF4-FFF2-40B4-BE49-F238E27FC236}">
                <a16:creationId xmlns:a16="http://schemas.microsoft.com/office/drawing/2014/main" id="{4C23B0E6-7AA0-2D03-F1D6-82EB401BF199}"/>
              </a:ext>
            </a:extLst>
          </p:cNvPr>
          <p:cNvGrpSpPr/>
          <p:nvPr/>
        </p:nvGrpSpPr>
        <p:grpSpPr>
          <a:xfrm>
            <a:off x="199076" y="390531"/>
            <a:ext cx="5205048" cy="1426493"/>
            <a:chOff x="319592" y="707773"/>
            <a:chExt cx="5205048" cy="1426493"/>
          </a:xfrm>
        </p:grpSpPr>
        <p:cxnSp>
          <p:nvCxnSpPr>
            <p:cNvPr id="56" name="Connettore diritto 55">
              <a:extLst>
                <a:ext uri="{FF2B5EF4-FFF2-40B4-BE49-F238E27FC236}">
                  <a16:creationId xmlns:a16="http://schemas.microsoft.com/office/drawing/2014/main" id="{2585BB0E-B07F-FDEA-3CAE-2EFDECDB6571}"/>
                </a:ext>
              </a:extLst>
            </p:cNvPr>
            <p:cNvCxnSpPr>
              <a:cxnSpLocks/>
            </p:cNvCxnSpPr>
            <p:nvPr/>
          </p:nvCxnSpPr>
          <p:spPr>
            <a:xfrm>
              <a:off x="2485245" y="1018694"/>
              <a:ext cx="0" cy="39734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cxnSp>
          <p:nvCxnSpPr>
            <p:cNvPr id="192" name="Connettore diritto 191">
              <a:extLst>
                <a:ext uri="{FF2B5EF4-FFF2-40B4-BE49-F238E27FC236}">
                  <a16:creationId xmlns:a16="http://schemas.microsoft.com/office/drawing/2014/main" id="{BCFC3511-0BF8-4C3D-7CFB-564B20E56583}"/>
                </a:ext>
              </a:extLst>
            </p:cNvPr>
            <p:cNvCxnSpPr>
              <a:cxnSpLocks/>
            </p:cNvCxnSpPr>
            <p:nvPr/>
          </p:nvCxnSpPr>
          <p:spPr>
            <a:xfrm>
              <a:off x="1142543" y="1018694"/>
              <a:ext cx="0" cy="39734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A05391A0-4076-66B8-42CB-083D3DD08850}"/>
                </a:ext>
              </a:extLst>
            </p:cNvPr>
            <p:cNvSpPr txBox="1"/>
            <p:nvPr/>
          </p:nvSpPr>
          <p:spPr>
            <a:xfrm>
              <a:off x="846628" y="1066807"/>
              <a:ext cx="59183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Surgery</a:t>
              </a:r>
            </a:p>
          </p:txBody>
        </p:sp>
        <p:cxnSp>
          <p:nvCxnSpPr>
            <p:cNvPr id="28" name="Connettore diritto 27">
              <a:extLst>
                <a:ext uri="{FF2B5EF4-FFF2-40B4-BE49-F238E27FC236}">
                  <a16:creationId xmlns:a16="http://schemas.microsoft.com/office/drawing/2014/main" id="{1696ABD3-74A1-0578-416D-54562FAF10DA}"/>
                </a:ext>
              </a:extLst>
            </p:cNvPr>
            <p:cNvCxnSpPr>
              <a:cxnSpLocks/>
            </p:cNvCxnSpPr>
            <p:nvPr/>
          </p:nvCxnSpPr>
          <p:spPr>
            <a:xfrm>
              <a:off x="1024640" y="1425958"/>
              <a:ext cx="4500000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  <a:headEnd type="oval" w="med" len="med"/>
              <a:tailEnd type="stealth" w="med" len="med"/>
            </a:ln>
            <a:effectLst/>
          </p:spPr>
        </p:cxn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2EBB0808-8DEA-15D1-8223-F149185D8C81}"/>
                </a:ext>
              </a:extLst>
            </p:cNvPr>
            <p:cNvSpPr txBox="1"/>
            <p:nvPr/>
          </p:nvSpPr>
          <p:spPr>
            <a:xfrm>
              <a:off x="631003" y="1536621"/>
              <a:ext cx="16053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it-IT" sz="600" b="1" kern="0" dirty="0">
                  <a:solidFill>
                    <a:schemeClr val="bg1"/>
                  </a:solidFill>
                </a:rPr>
                <a:t>T</a:t>
              </a:r>
              <a:endParaRPr kumimoji="0" lang="it-IT" sz="600" b="1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</a:endParaRPr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317E86D0-9508-3994-0827-352E8064FDC0}"/>
                </a:ext>
              </a:extLst>
            </p:cNvPr>
            <p:cNvSpPr txBox="1"/>
            <p:nvPr/>
          </p:nvSpPr>
          <p:spPr>
            <a:xfrm>
              <a:off x="1155258" y="1795712"/>
              <a:ext cx="6105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MRI </a:t>
              </a:r>
              <a:r>
                <a:rPr lang="it-IT" sz="800" dirty="0" err="1"/>
                <a:t>scan</a:t>
              </a:r>
              <a:r>
                <a:rPr lang="it-IT" sz="800" dirty="0"/>
                <a:t> (2013)</a:t>
              </a:r>
            </a:p>
          </p:txBody>
        </p:sp>
        <p:sp>
          <p:nvSpPr>
            <p:cNvPr id="43" name="CasellaDiTesto 42">
              <a:extLst>
                <a:ext uri="{FF2B5EF4-FFF2-40B4-BE49-F238E27FC236}">
                  <a16:creationId xmlns:a16="http://schemas.microsoft.com/office/drawing/2014/main" id="{824A9DE1-A441-B04C-937A-FE99B8C2D6C1}"/>
                </a:ext>
              </a:extLst>
            </p:cNvPr>
            <p:cNvSpPr txBox="1"/>
            <p:nvPr/>
          </p:nvSpPr>
          <p:spPr>
            <a:xfrm>
              <a:off x="1472321" y="1428769"/>
              <a:ext cx="62388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i="1" dirty="0"/>
                <a:t>36 </a:t>
              </a:r>
              <a:r>
                <a:rPr lang="it-IT" sz="800" i="1" dirty="0" err="1"/>
                <a:t>months</a:t>
              </a:r>
              <a:endParaRPr lang="it-IT" sz="800" i="1" dirty="0"/>
            </a:p>
          </p:txBody>
        </p:sp>
        <p:sp>
          <p:nvSpPr>
            <p:cNvPr id="54" name="Ovale 53">
              <a:extLst>
                <a:ext uri="{FF2B5EF4-FFF2-40B4-BE49-F238E27FC236}">
                  <a16:creationId xmlns:a16="http://schemas.microsoft.com/office/drawing/2014/main" id="{1A2F0CDD-3BEB-1274-E9F9-8F567D7F1984}"/>
                </a:ext>
              </a:extLst>
            </p:cNvPr>
            <p:cNvSpPr/>
            <p:nvPr/>
          </p:nvSpPr>
          <p:spPr>
            <a:xfrm>
              <a:off x="1103898" y="1385839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5" name="Ovale 54">
              <a:extLst>
                <a:ext uri="{FF2B5EF4-FFF2-40B4-BE49-F238E27FC236}">
                  <a16:creationId xmlns:a16="http://schemas.microsoft.com/office/drawing/2014/main" id="{EFCDCAE9-FA06-6E76-95D7-C74A188BE5CB}"/>
                </a:ext>
              </a:extLst>
            </p:cNvPr>
            <p:cNvSpPr/>
            <p:nvPr/>
          </p:nvSpPr>
          <p:spPr>
            <a:xfrm>
              <a:off x="2451849" y="1385839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7001D4D6-497A-8F1F-749E-2CC13277C767}"/>
                </a:ext>
              </a:extLst>
            </p:cNvPr>
            <p:cNvSpPr txBox="1"/>
            <p:nvPr/>
          </p:nvSpPr>
          <p:spPr>
            <a:xfrm>
              <a:off x="2184791" y="1061035"/>
              <a:ext cx="59183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Surgery</a:t>
              </a:r>
            </a:p>
          </p:txBody>
        </p:sp>
        <p:pic>
          <p:nvPicPr>
            <p:cNvPr id="65" name="Immagine 64">
              <a:extLst>
                <a:ext uri="{FF2B5EF4-FFF2-40B4-BE49-F238E27FC236}">
                  <a16:creationId xmlns:a16="http://schemas.microsoft.com/office/drawing/2014/main" id="{DDDE0A86-A61E-2BFA-83A3-88182BB6F74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79708" y="707773"/>
              <a:ext cx="532364" cy="360000"/>
            </a:xfrm>
            <a:prstGeom prst="rect">
              <a:avLst/>
            </a:prstGeom>
          </p:spPr>
        </p:pic>
        <p:sp>
          <p:nvSpPr>
            <p:cNvPr id="68" name="Rettangolo con angoli arrotondati 67">
              <a:extLst>
                <a:ext uri="{FF2B5EF4-FFF2-40B4-BE49-F238E27FC236}">
                  <a16:creationId xmlns:a16="http://schemas.microsoft.com/office/drawing/2014/main" id="{F4AF1323-29E9-BC8A-85A6-A93606DB2CA5}"/>
                </a:ext>
              </a:extLst>
            </p:cNvPr>
            <p:cNvSpPr/>
            <p:nvPr/>
          </p:nvSpPr>
          <p:spPr>
            <a:xfrm>
              <a:off x="2815991" y="1333471"/>
              <a:ext cx="727943" cy="162509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id="{74BF1B8B-CAE9-E496-0A81-F7437CF4BC3B}"/>
                </a:ext>
              </a:extLst>
            </p:cNvPr>
            <p:cNvSpPr txBox="1"/>
            <p:nvPr/>
          </p:nvSpPr>
          <p:spPr>
            <a:xfrm>
              <a:off x="2897690" y="1133461"/>
              <a:ext cx="5725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i="1" dirty="0"/>
                <a:t>2 </a:t>
              </a:r>
              <a:r>
                <a:rPr lang="it-IT" sz="800" i="1" dirty="0" err="1"/>
                <a:t>months</a:t>
              </a:r>
              <a:endParaRPr lang="it-IT" sz="800" i="1" dirty="0"/>
            </a:p>
          </p:txBody>
        </p:sp>
        <p:pic>
          <p:nvPicPr>
            <p:cNvPr id="71" name="Immagine 70">
              <a:extLst>
                <a:ext uri="{FF2B5EF4-FFF2-40B4-BE49-F238E27FC236}">
                  <a16:creationId xmlns:a16="http://schemas.microsoft.com/office/drawing/2014/main" id="{D1AAE96C-54EA-C01C-DDB6-A952C9E7A4D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88282" y="865705"/>
              <a:ext cx="198438" cy="144000"/>
            </a:xfrm>
            <a:prstGeom prst="rect">
              <a:avLst/>
            </a:prstGeom>
          </p:spPr>
        </p:pic>
        <p:pic>
          <p:nvPicPr>
            <p:cNvPr id="73" name="Immagine 72">
              <a:extLst>
                <a:ext uri="{FF2B5EF4-FFF2-40B4-BE49-F238E27FC236}">
                  <a16:creationId xmlns:a16="http://schemas.microsoft.com/office/drawing/2014/main" id="{94DA8887-ECF4-2003-659D-DBC8A04A475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19013" y="865705"/>
              <a:ext cx="198438" cy="144000"/>
            </a:xfrm>
            <a:prstGeom prst="rect">
              <a:avLst/>
            </a:prstGeom>
          </p:spPr>
        </p:pic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123F249E-913F-F38B-9D50-AAC8FBB496BD}"/>
                </a:ext>
              </a:extLst>
            </p:cNvPr>
            <p:cNvSpPr txBox="1"/>
            <p:nvPr/>
          </p:nvSpPr>
          <p:spPr>
            <a:xfrm>
              <a:off x="2747410" y="1305370"/>
              <a:ext cx="8735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80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dj</a:t>
              </a:r>
              <a:r>
                <a:rPr kumimoji="0" lang="it-IT" sz="80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therapy + RT</a:t>
              </a:r>
            </a:p>
          </p:txBody>
        </p: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D81C7E63-531C-D3A0-2A60-92259A96BE57}"/>
                </a:ext>
              </a:extLst>
            </p:cNvPr>
            <p:cNvSpPr txBox="1"/>
            <p:nvPr/>
          </p:nvSpPr>
          <p:spPr>
            <a:xfrm>
              <a:off x="2506417" y="1795712"/>
              <a:ext cx="6105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MRI </a:t>
              </a:r>
              <a:r>
                <a:rPr lang="it-IT" sz="800" dirty="0" err="1"/>
                <a:t>scan</a:t>
              </a:r>
              <a:r>
                <a:rPr lang="it-IT" sz="800" dirty="0"/>
                <a:t> (2016)</a:t>
              </a:r>
            </a:p>
          </p:txBody>
        </p: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id="{44F24FE5-EF4A-A85E-3C60-AF9493CC9DA3}"/>
                </a:ext>
              </a:extLst>
            </p:cNvPr>
            <p:cNvSpPr txBox="1"/>
            <p:nvPr/>
          </p:nvSpPr>
          <p:spPr>
            <a:xfrm>
              <a:off x="4222592" y="1428769"/>
              <a:ext cx="62388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i="1" dirty="0"/>
                <a:t>58 </a:t>
              </a:r>
              <a:r>
                <a:rPr lang="it-IT" sz="800" i="1" dirty="0" err="1"/>
                <a:t>months</a:t>
              </a:r>
              <a:endParaRPr lang="it-IT" sz="800" i="1" dirty="0"/>
            </a:p>
          </p:txBody>
        </p:sp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3134C3CF-D97F-7B1D-61AD-BF2976CFB55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30930" y="707773"/>
              <a:ext cx="528210" cy="360000"/>
            </a:xfrm>
            <a:prstGeom prst="rect">
              <a:avLst/>
            </a:prstGeom>
          </p:spPr>
        </p:pic>
        <p:cxnSp>
          <p:nvCxnSpPr>
            <p:cNvPr id="190" name="Connettore diritto 189">
              <a:extLst>
                <a:ext uri="{FF2B5EF4-FFF2-40B4-BE49-F238E27FC236}">
                  <a16:creationId xmlns:a16="http://schemas.microsoft.com/office/drawing/2014/main" id="{A95323E8-4EF5-4732-F49E-5EABA2C873BB}"/>
                </a:ext>
              </a:extLst>
            </p:cNvPr>
            <p:cNvCxnSpPr>
              <a:cxnSpLocks/>
            </p:cNvCxnSpPr>
            <p:nvPr/>
          </p:nvCxnSpPr>
          <p:spPr>
            <a:xfrm>
              <a:off x="1022101" y="1426234"/>
              <a:ext cx="0" cy="9730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191" name="CasellaDiTesto 190">
              <a:extLst>
                <a:ext uri="{FF2B5EF4-FFF2-40B4-BE49-F238E27FC236}">
                  <a16:creationId xmlns:a16="http://schemas.microsoft.com/office/drawing/2014/main" id="{43BB9105-80D0-6CFE-10AB-4486B187317D}"/>
                </a:ext>
              </a:extLst>
            </p:cNvPr>
            <p:cNvSpPr txBox="1"/>
            <p:nvPr/>
          </p:nvSpPr>
          <p:spPr>
            <a:xfrm>
              <a:off x="319592" y="1287256"/>
              <a:ext cx="7008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iagnosis</a:t>
              </a:r>
              <a:endParaRPr kumimoji="0" lang="it-IT" sz="10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01" name="Ovale 200">
              <a:extLst>
                <a:ext uri="{FF2B5EF4-FFF2-40B4-BE49-F238E27FC236}">
                  <a16:creationId xmlns:a16="http://schemas.microsoft.com/office/drawing/2014/main" id="{3EED6E9C-6E34-A651-812D-2BD575A7DEF6}"/>
                </a:ext>
              </a:extLst>
            </p:cNvPr>
            <p:cNvSpPr/>
            <p:nvPr/>
          </p:nvSpPr>
          <p:spPr>
            <a:xfrm>
              <a:off x="2341246" y="1385839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202" name="Connettore diritto 201">
              <a:extLst>
                <a:ext uri="{FF2B5EF4-FFF2-40B4-BE49-F238E27FC236}">
                  <a16:creationId xmlns:a16="http://schemas.microsoft.com/office/drawing/2014/main" id="{4D270EFA-5ED6-998D-CBC4-540DA911E43F}"/>
                </a:ext>
              </a:extLst>
            </p:cNvPr>
            <p:cNvCxnSpPr>
              <a:cxnSpLocks/>
            </p:cNvCxnSpPr>
            <p:nvPr/>
          </p:nvCxnSpPr>
          <p:spPr>
            <a:xfrm>
              <a:off x="2375921" y="1426234"/>
              <a:ext cx="0" cy="9730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pic>
          <p:nvPicPr>
            <p:cNvPr id="2" name="Immagine 1">
              <a:extLst>
                <a:ext uri="{FF2B5EF4-FFF2-40B4-BE49-F238E27FC236}">
                  <a16:creationId xmlns:a16="http://schemas.microsoft.com/office/drawing/2014/main" id="{DD020AF9-4003-0EC6-9F49-1FEA21D5C8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719" t="4803" r="20084" b="1480"/>
            <a:stretch/>
          </p:blipFill>
          <p:spPr>
            <a:xfrm>
              <a:off x="798243" y="1544966"/>
              <a:ext cx="457641" cy="540000"/>
            </a:xfrm>
            <a:prstGeom prst="rect">
              <a:avLst/>
            </a:prstGeom>
          </p:spPr>
        </p:pic>
        <p:cxnSp>
          <p:nvCxnSpPr>
            <p:cNvPr id="11" name="Connettore 2 10">
              <a:extLst>
                <a:ext uri="{FF2B5EF4-FFF2-40B4-BE49-F238E27FC236}">
                  <a16:creationId xmlns:a16="http://schemas.microsoft.com/office/drawing/2014/main" id="{7AA7D1FA-3A77-F596-C969-F3BB00B813D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022364" y="1735183"/>
              <a:ext cx="67076" cy="108200"/>
            </a:xfrm>
            <a:prstGeom prst="straightConnector1">
              <a:avLst/>
            </a:prstGeom>
            <a:ln w="3175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Immagine 16">
              <a:extLst>
                <a:ext uri="{FF2B5EF4-FFF2-40B4-BE49-F238E27FC236}">
                  <a16:creationId xmlns:a16="http://schemas.microsoft.com/office/drawing/2014/main" id="{049595E4-6213-0359-3D00-0DD019DA38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00" t="4281" r="13053" b="9076"/>
            <a:stretch/>
          </p:blipFill>
          <p:spPr>
            <a:xfrm>
              <a:off x="2151548" y="1544016"/>
              <a:ext cx="450314" cy="540000"/>
            </a:xfrm>
            <a:prstGeom prst="rect">
              <a:avLst/>
            </a:prstGeom>
          </p:spPr>
        </p:pic>
        <p:cxnSp>
          <p:nvCxnSpPr>
            <p:cNvPr id="18" name="Connettore 2 17">
              <a:extLst>
                <a:ext uri="{FF2B5EF4-FFF2-40B4-BE49-F238E27FC236}">
                  <a16:creationId xmlns:a16="http://schemas.microsoft.com/office/drawing/2014/main" id="{3ACA83DD-9B28-4314-5FAE-D6894EFFED1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331975" y="1767093"/>
              <a:ext cx="67076" cy="108200"/>
            </a:xfrm>
            <a:prstGeom prst="straightConnector1">
              <a:avLst/>
            </a:prstGeom>
            <a:ln w="3175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203" name="Tabella 21">
            <a:extLst>
              <a:ext uri="{FF2B5EF4-FFF2-40B4-BE49-F238E27FC236}">
                <a16:creationId xmlns:a16="http://schemas.microsoft.com/office/drawing/2014/main" id="{4D676D86-3F08-D401-A576-7DFBCC5948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4568573"/>
              </p:ext>
            </p:extLst>
          </p:nvPr>
        </p:nvGraphicFramePr>
        <p:xfrm>
          <a:off x="5648581" y="320650"/>
          <a:ext cx="3187395" cy="1460356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394767">
                  <a:extLst>
                    <a:ext uri="{9D8B030D-6E8A-4147-A177-3AD203B41FA5}">
                      <a16:colId xmlns:a16="http://schemas.microsoft.com/office/drawing/2014/main" val="1103561328"/>
                    </a:ext>
                  </a:extLst>
                </a:gridCol>
                <a:gridCol w="465438">
                  <a:extLst>
                    <a:ext uri="{9D8B030D-6E8A-4147-A177-3AD203B41FA5}">
                      <a16:colId xmlns:a16="http://schemas.microsoft.com/office/drawing/2014/main" val="1181760618"/>
                    </a:ext>
                  </a:extLst>
                </a:gridCol>
                <a:gridCol w="465438">
                  <a:extLst>
                    <a:ext uri="{9D8B030D-6E8A-4147-A177-3AD203B41FA5}">
                      <a16:colId xmlns:a16="http://schemas.microsoft.com/office/drawing/2014/main" val="259463069"/>
                    </a:ext>
                  </a:extLst>
                </a:gridCol>
                <a:gridCol w="46543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65438">
                  <a:extLst>
                    <a:ext uri="{9D8B030D-6E8A-4147-A177-3AD203B41FA5}">
                      <a16:colId xmlns:a16="http://schemas.microsoft.com/office/drawing/2014/main" val="713198755"/>
                    </a:ext>
                  </a:extLst>
                </a:gridCol>
                <a:gridCol w="465438">
                  <a:extLst>
                    <a:ext uri="{9D8B030D-6E8A-4147-A177-3AD203B41FA5}">
                      <a16:colId xmlns:a16="http://schemas.microsoft.com/office/drawing/2014/main" val="1952847646"/>
                    </a:ext>
                  </a:extLst>
                </a:gridCol>
                <a:gridCol w="46543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55596">
                <a:tc rowSpan="2"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it-IT" sz="1000" b="0" i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lang="it-IT" sz="1000" b="0" i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P53 p.R273H</a:t>
                      </a:r>
                    </a:p>
                  </a:txBody>
                  <a:tcPr marL="45720" marR="45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it-IT" sz="1000" b="1" i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081842733"/>
                  </a:ext>
                </a:extLst>
              </a:tr>
              <a:tr h="264738">
                <a:tc vMerge="1"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it-IT" sz="10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Tumor</a:t>
                      </a:r>
                      <a:endParaRPr lang="it-IT" sz="1000" baseline="-25000" dirty="0"/>
                    </a:p>
                  </a:txBody>
                  <a:tcPr marL="45720" marR="45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9503F">
                        <a:alpha val="8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RM</a:t>
                      </a:r>
                      <a:r>
                        <a:rPr lang="it-IT" sz="1000" baseline="-25000" dirty="0"/>
                        <a:t>I</a:t>
                      </a:r>
                      <a:endParaRPr lang="it-IT" sz="1000" dirty="0"/>
                    </a:p>
                  </a:txBody>
                  <a:tcPr marL="45720" marR="45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60000"/>
                        <a:lumOff val="40000"/>
                        <a:alpha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000" dirty="0"/>
                        <a:t>RM</a:t>
                      </a:r>
                      <a:r>
                        <a:rPr lang="it-IT" sz="1000" baseline="-25000" dirty="0"/>
                        <a:t>II</a:t>
                      </a:r>
                      <a:endParaRPr lang="it-IT" sz="1000" dirty="0"/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60000"/>
                        <a:lumOff val="40000"/>
                        <a:alpha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LN</a:t>
                      </a:r>
                      <a:r>
                        <a:rPr lang="it-IT" sz="1000" baseline="30000" dirty="0"/>
                        <a:t>-</a:t>
                      </a:r>
                      <a:r>
                        <a:rPr lang="it-IT" sz="1000" baseline="-25000" dirty="0"/>
                        <a:t>I</a:t>
                      </a:r>
                      <a:endParaRPr lang="it-IT" sz="1000" baseline="30000" dirty="0"/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60000"/>
                        <a:lumOff val="40000"/>
                        <a:alpha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LN</a:t>
                      </a:r>
                      <a:r>
                        <a:rPr lang="it-IT" sz="1000" baseline="30000" dirty="0"/>
                        <a:t>-</a:t>
                      </a:r>
                      <a:r>
                        <a:rPr lang="it-IT" sz="1000" baseline="-25000" dirty="0"/>
                        <a:t>II</a:t>
                      </a:r>
                      <a:endParaRPr lang="it-IT" sz="1000" baseline="30000" dirty="0"/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60000"/>
                        <a:lumOff val="40000"/>
                        <a:alpha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LN</a:t>
                      </a:r>
                      <a:r>
                        <a:rPr lang="it-IT" sz="1000" baseline="30000" dirty="0"/>
                        <a:t>-</a:t>
                      </a:r>
                      <a:r>
                        <a:rPr lang="it-IT" sz="1000" baseline="-25000" dirty="0"/>
                        <a:t>III</a:t>
                      </a:r>
                      <a:endParaRPr lang="it-IT" sz="1000" baseline="30000" dirty="0"/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60000"/>
                        <a:lumOff val="40000"/>
                        <a:alpha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7010439"/>
                  </a:ext>
                </a:extLst>
              </a:tr>
              <a:tr h="231645"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NGS</a:t>
                      </a:r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11.8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5.0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d</a:t>
                      </a:r>
                      <a:endParaRPr lang="it-IT" sz="900" dirty="0"/>
                    </a:p>
                  </a:txBody>
                  <a:tcPr marL="45720" marR="4572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0.5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0.2%</a:t>
                      </a:r>
                    </a:p>
                  </a:txBody>
                  <a:tcPr marL="45720" marR="4572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0.5%</a:t>
                      </a:r>
                    </a:p>
                  </a:txBody>
                  <a:tcPr marL="45720" marR="4572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167185016"/>
                  </a:ext>
                </a:extLst>
              </a:tr>
              <a:tr h="231645"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dPCR</a:t>
                      </a:r>
                      <a:endParaRPr lang="it-IT" sz="900" dirty="0"/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12.6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/>
                        <a:t>5.6%</a:t>
                      </a:r>
                      <a:endParaRPr lang="it-IT" sz="900" dirty="0"/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9.3%</a:t>
                      </a:r>
                    </a:p>
                  </a:txBody>
                  <a:tcPr marL="45720" marR="4572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0.4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0.2%</a:t>
                      </a:r>
                    </a:p>
                  </a:txBody>
                  <a:tcPr marL="45720" marR="4572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0.2%</a:t>
                      </a:r>
                    </a:p>
                  </a:txBody>
                  <a:tcPr marL="45720" marR="4572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2484683"/>
                  </a:ext>
                </a:extLst>
              </a:tr>
              <a:tr h="238366"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NGS</a:t>
                      </a:r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34.0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/>
                        <a:t>0.2%</a:t>
                      </a:r>
                      <a:endParaRPr lang="it-IT" sz="900" dirty="0"/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d</a:t>
                      </a:r>
                      <a:endParaRPr lang="it-IT" sz="900" dirty="0"/>
                    </a:p>
                  </a:txBody>
                  <a:tcPr marL="45720" marR="4572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3878668"/>
                  </a:ext>
                </a:extLst>
              </a:tr>
              <a:tr h="238366"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dPCR</a:t>
                      </a:r>
                      <a:endParaRPr lang="it-IT" sz="900" dirty="0"/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33.9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/>
                        <a:t>0.1%</a:t>
                      </a:r>
                      <a:endParaRPr lang="it-IT" sz="900" dirty="0"/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0.2%</a:t>
                      </a:r>
                    </a:p>
                  </a:txBody>
                  <a:tcPr marL="45720" marR="4572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6722444"/>
                  </a:ext>
                </a:extLst>
              </a:tr>
            </a:tbl>
          </a:graphicData>
        </a:graphic>
      </p:graphicFrame>
      <p:sp>
        <p:nvSpPr>
          <p:cNvPr id="204" name="CasellaDiTesto 203">
            <a:extLst>
              <a:ext uri="{FF2B5EF4-FFF2-40B4-BE49-F238E27FC236}">
                <a16:creationId xmlns:a16="http://schemas.microsoft.com/office/drawing/2014/main" id="{B748D70B-9C8E-4EB1-5364-E56ECE3AB6E1}"/>
              </a:ext>
            </a:extLst>
          </p:cNvPr>
          <p:cNvSpPr txBox="1"/>
          <p:nvPr/>
        </p:nvSpPr>
        <p:spPr>
          <a:xfrm>
            <a:off x="8858801" y="847967"/>
            <a:ext cx="6190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i="1" dirty="0" err="1"/>
              <a:t>Primary</a:t>
            </a:r>
            <a:r>
              <a:rPr lang="it-IT" sz="1000" i="1" dirty="0"/>
              <a:t> </a:t>
            </a:r>
          </a:p>
          <a:p>
            <a:r>
              <a:rPr lang="it-IT" sz="1000" i="1" dirty="0" err="1"/>
              <a:t>tumor</a:t>
            </a:r>
            <a:endParaRPr lang="it-IT" sz="1000" i="1" dirty="0"/>
          </a:p>
        </p:txBody>
      </p:sp>
      <p:sp>
        <p:nvSpPr>
          <p:cNvPr id="205" name="CasellaDiTesto 204">
            <a:extLst>
              <a:ext uri="{FF2B5EF4-FFF2-40B4-BE49-F238E27FC236}">
                <a16:creationId xmlns:a16="http://schemas.microsoft.com/office/drawing/2014/main" id="{A7A2318A-19AD-ADB6-3F7C-CC0801AE2649}"/>
              </a:ext>
            </a:extLst>
          </p:cNvPr>
          <p:cNvSpPr txBox="1"/>
          <p:nvPr/>
        </p:nvSpPr>
        <p:spPr>
          <a:xfrm>
            <a:off x="8858801" y="1424292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i="1" dirty="0"/>
              <a:t>Recurrence</a:t>
            </a:r>
          </a:p>
        </p:txBody>
      </p:sp>
      <p:sp>
        <p:nvSpPr>
          <p:cNvPr id="219" name="CasellaDiTesto 218">
            <a:extLst>
              <a:ext uri="{FF2B5EF4-FFF2-40B4-BE49-F238E27FC236}">
                <a16:creationId xmlns:a16="http://schemas.microsoft.com/office/drawing/2014/main" id="{85AFB9E7-5988-0EF5-0282-05261A756555}"/>
              </a:ext>
            </a:extLst>
          </p:cNvPr>
          <p:cNvSpPr txBox="1"/>
          <p:nvPr/>
        </p:nvSpPr>
        <p:spPr>
          <a:xfrm>
            <a:off x="5448897" y="123036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b</a:t>
            </a:r>
          </a:p>
        </p:txBody>
      </p:sp>
      <p:sp>
        <p:nvSpPr>
          <p:cNvPr id="224" name="CasellaDiTesto 223">
            <a:extLst>
              <a:ext uri="{FF2B5EF4-FFF2-40B4-BE49-F238E27FC236}">
                <a16:creationId xmlns:a16="http://schemas.microsoft.com/office/drawing/2014/main" id="{3F1D6FBA-2621-0306-D77F-BAB0D75E7211}"/>
              </a:ext>
            </a:extLst>
          </p:cNvPr>
          <p:cNvSpPr txBox="1"/>
          <p:nvPr/>
        </p:nvSpPr>
        <p:spPr>
          <a:xfrm>
            <a:off x="105697" y="1883360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c</a:t>
            </a:r>
          </a:p>
        </p:txBody>
      </p:sp>
      <p:pic>
        <p:nvPicPr>
          <p:cNvPr id="78" name="Immagine 77" descr="Immagine che contiene violetto, Policromia, Lilac, schermata&#10;&#10;Descrizione generata automaticamente">
            <a:extLst>
              <a:ext uri="{FF2B5EF4-FFF2-40B4-BE49-F238E27FC236}">
                <a16:creationId xmlns:a16="http://schemas.microsoft.com/office/drawing/2014/main" id="{CD6DD410-BCC9-25FE-3220-B2F3AFBD4D9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362" y="2320207"/>
            <a:ext cx="8404249" cy="39762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07666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Widescreen</PresentationFormat>
  <Paragraphs>52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418</cp:revision>
  <cp:lastPrinted>2023-10-12T13:56:18Z</cp:lastPrinted>
  <dcterms:created xsi:type="dcterms:W3CDTF">2022-08-04T15:26:16Z</dcterms:created>
  <dcterms:modified xsi:type="dcterms:W3CDTF">2024-02-13T22:26:56Z</dcterms:modified>
</cp:coreProperties>
</file>